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74" d="100"/>
          <a:sy n="74" d="100"/>
        </p:scale>
        <p:origin x="352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4F8BF7-E196-A34F-A640-EE4D716F51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557BB39-8DF7-8F40-867F-4C18AB4130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892600-DADB-DA4F-AB7F-756658191C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8F2FC3-8126-B947-83EC-49C5BFA2D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C2AF05-9529-7A4A-9047-4FFFD56D6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0815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7E6AD5-40A6-9744-B0CE-8AA70A36F9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967A4A9-489E-F446-88A4-7BFF65D95B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CFF872-A689-F644-BBE5-CC9633790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8DD66B-1400-1743-98F9-0290C99CC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B06097-98C3-B445-B41D-F83302B09D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73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6B63B63-01F9-B442-8369-8CB42F1F87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68B4A9-49D7-0549-A6B9-12FBAC61DB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951886-B252-9447-BE63-D86B25357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FBF310-DA05-B845-A0DB-A75C0507A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F38386-D9AD-CC49-8AB3-5F46E9AF9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315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A3F0D6-D904-754C-8314-6E13C9AEFC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E6D1037-BE2E-AD4D-9F6C-EA7E072B5B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A2FE3D-9622-5648-B707-73BBA6C64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8153A3-D8A7-4D4B-9843-76B249DDD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CE759B-96C8-9545-ACA2-C828E5885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877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255B82-6938-E442-BBCE-48F7A18E0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E95438-C803-2C41-8DC7-AA705724C1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4E84F7-6EAA-4543-A47F-4257ECE9E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402BFA-4980-DF4F-9C9F-7AC77E30A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6CBFE7-BA75-514E-B886-0E91A1076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6220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5834B3-6380-A145-B50E-77D5094590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968C38-E8B7-9940-84B0-D997DAB2AF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B03DD93-7871-874D-9DB6-F266BEE934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09750A-134B-CF43-99C7-28B7FCACE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75574C6-2B08-C243-9D80-CB815A490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A6F3960-4710-F846-8AA4-C105B7A2D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9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9A041D-72D9-D84E-BF51-A5AEBF4029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D5B8D73-0F90-8C40-9A7E-957968B70C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78D46A2-76D2-104C-BC10-42B5396A17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83AA05E-7EBB-D04D-88C5-BBFBF38B98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69AA2D9-C903-F847-ACAC-C02A34DC51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314A840-5584-584C-B274-C557249DE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7FCD706-FC96-2948-BE8B-4B39D626B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6564E06-2130-B642-AE87-A46AD2C4D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072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6FD4D3-1A05-EA44-9BB0-F5CA9BFF30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B87598-E781-7F4B-896A-746AD02E8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99A1B00-20EA-8842-ABE1-6C90ED85D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17DA0C8-8625-8649-88E9-F08768076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220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18FF261-0643-5C4F-8275-A4D05278C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8298F5B-1EAA-6142-9599-F50FE06DE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CE79253-8CD3-D84C-999C-F2C267A51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576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B6C2F4-1086-724A-B27C-06E5554F9C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6841E6-36A3-7546-8C90-9F598D750E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56E8D53-EABD-E541-8144-B06595D042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0AC760-81F2-3749-A6F7-562FF38CE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8F11D0D-5BEB-934B-AD0E-2AB47E5B0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F086EE-3AB0-9C42-B11D-D0B9FF38A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8831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684BD1-44D6-F042-A5BB-1EA3A11A5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00F0DCD-1457-7D48-9935-07EE901AA5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5BA4E80-43C2-1647-B468-B3C4414E3C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0BD28D1-07BC-5046-9209-A2EEB5BBA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6C403D-413C-7146-9756-D17CD279A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F21676-CD26-5145-8472-F24C48A21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479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8E4E6FB-BA43-684A-8930-35C9A6CA5E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17A94DC-8740-A344-8F73-7C0724EE06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FFB7E4-7010-1B48-80CD-D0FD64539E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E1B218-30CB-6543-A5E7-E2444F7A2F16}" type="datetimeFigureOut">
              <a:rPr kumimoji="1" lang="ja-JP" altLang="en-US" smtClean="0"/>
              <a:t>2022/8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47485F-577B-704B-B0BB-5FC6E1847D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6BD577-4018-394B-A738-21E92F1B98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976F7-E373-9F45-B702-EF8BE6EED3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802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0B235218-441B-ED46-A5D1-287A23A461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4576157"/>
              </p:ext>
            </p:extLst>
          </p:nvPr>
        </p:nvGraphicFramePr>
        <p:xfrm>
          <a:off x="1041943" y="1306408"/>
          <a:ext cx="8009590" cy="22233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28553">
                  <a:extLst>
                    <a:ext uri="{9D8B030D-6E8A-4147-A177-3AD203B41FA5}">
                      <a16:colId xmlns:a16="http://schemas.microsoft.com/office/drawing/2014/main" val="2170053968"/>
                    </a:ext>
                  </a:extLst>
                </a:gridCol>
                <a:gridCol w="710386">
                  <a:extLst>
                    <a:ext uri="{9D8B030D-6E8A-4147-A177-3AD203B41FA5}">
                      <a16:colId xmlns:a16="http://schemas.microsoft.com/office/drawing/2014/main" val="3565507015"/>
                    </a:ext>
                  </a:extLst>
                </a:gridCol>
                <a:gridCol w="328553">
                  <a:extLst>
                    <a:ext uri="{9D8B030D-6E8A-4147-A177-3AD203B41FA5}">
                      <a16:colId xmlns:a16="http://schemas.microsoft.com/office/drawing/2014/main" val="1114565278"/>
                    </a:ext>
                  </a:extLst>
                </a:gridCol>
                <a:gridCol w="2786484">
                  <a:extLst>
                    <a:ext uri="{9D8B030D-6E8A-4147-A177-3AD203B41FA5}">
                      <a16:colId xmlns:a16="http://schemas.microsoft.com/office/drawing/2014/main" val="393069693"/>
                    </a:ext>
                  </a:extLst>
                </a:gridCol>
                <a:gridCol w="534564">
                  <a:extLst>
                    <a:ext uri="{9D8B030D-6E8A-4147-A177-3AD203B41FA5}">
                      <a16:colId xmlns:a16="http://schemas.microsoft.com/office/drawing/2014/main" val="2923483586"/>
                    </a:ext>
                  </a:extLst>
                </a:gridCol>
                <a:gridCol w="2992497">
                  <a:extLst>
                    <a:ext uri="{9D8B030D-6E8A-4147-A177-3AD203B41FA5}">
                      <a16:colId xmlns:a16="http://schemas.microsoft.com/office/drawing/2014/main" val="614521037"/>
                    </a:ext>
                  </a:extLst>
                </a:gridCol>
                <a:gridCol w="328553">
                  <a:extLst>
                    <a:ext uri="{9D8B030D-6E8A-4147-A177-3AD203B41FA5}">
                      <a16:colId xmlns:a16="http://schemas.microsoft.com/office/drawing/2014/main" val="259985478"/>
                    </a:ext>
                  </a:extLst>
                </a:gridCol>
              </a:tblGrid>
              <a:tr h="100374"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2503730630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 (5'-3')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(5'-3')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405112148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CCGTCAAGGCTGAGAA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TGAAGACGCCAGTGGA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732966602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CGGGTGAGCAGTAG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GGTTATAGGGAGGTCAA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3960176556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1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TGGACTGTTTTCTCTC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CAGCATTGTGGGAGGA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219828930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-3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GGTCTGGTACAGATGTCGAT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TAACCCGGGTAAGAATGTGCA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45485416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-7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GACAGGTATGGGCGTTC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TCTATCCCCCCTAAAGTG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1349331036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2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CCGGCAAGATTTTAGTA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AAATCCGCTTGTTAGG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3654958836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4/6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GTCCTACTACTTCAAATGTGTG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TCGCACTTCTGTTCCT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913665269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2f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CGGCGCATCTATGAC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CTGTCAGTGTCCTC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791682590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ATCAGATGAAGCAGATG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ATTCGTGTTCGAGTAGAAG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ja-JP" sz="1200" b="0" i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4129415109"/>
                  </a:ext>
                </a:extLst>
              </a:tr>
              <a:tr h="158687"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tc>
                  <a:txBody>
                    <a:bodyPr/>
                    <a:lstStyle/>
                    <a:p>
                      <a:endParaRPr lang="ja-JP" sz="1200" b="0" i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403" marR="2403" marT="2403" marB="0" anchor="b"/>
                </a:tc>
                <a:extLst>
                  <a:ext uri="{0D108BD9-81ED-4DB2-BD59-A6C34878D82A}">
                    <a16:rowId xmlns:a16="http://schemas.microsoft.com/office/drawing/2014/main" val="722704431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B7D05D5E-4B4C-A04F-81D3-542DE9B5C4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1943" y="487952"/>
            <a:ext cx="3249158" cy="5516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38576" tIns="19288" rIns="38576" bIns="19288" numCol="1" anchor="ctr" anchorCtr="0" compatLnSpc="1">
            <a:prstTxWarp prst="textNoShape">
              <a:avLst/>
            </a:prstTxWarp>
            <a:spAutoFit/>
          </a:bodyPr>
          <a:lstStyle/>
          <a:p>
            <a:pPr defTabSz="38575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ja-JP" altLang="ja-JP" sz="1286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1 </a:t>
            </a:r>
            <a:endParaRPr lang="ja-JP" altLang="ja-JP" sz="1286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38575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ja-JP" altLang="ja-JP" sz="1286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ers used for Quantitative real-time PCR</a:t>
            </a:r>
            <a:endParaRPr lang="ja-JP" altLang="ja-JP" sz="1286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385752" eaLnBrk="0" fontAlgn="base" hangingPunct="0">
              <a:spcBef>
                <a:spcPct val="0"/>
              </a:spcBef>
              <a:spcAft>
                <a:spcPct val="0"/>
              </a:spcAft>
            </a:pPr>
            <a:endParaRPr lang="ja-JP" altLang="ja-JP" sz="76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1738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Office PowerPoint</Application>
  <PresentationFormat>Widescreen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游明朝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江副 幸子</dc:creator>
  <cp:lastModifiedBy>Selvilakshmi R</cp:lastModifiedBy>
  <cp:revision>2</cp:revision>
  <dcterms:created xsi:type="dcterms:W3CDTF">2022-04-12T04:19:18Z</dcterms:created>
  <dcterms:modified xsi:type="dcterms:W3CDTF">2022-08-12T11:21:30Z</dcterms:modified>
</cp:coreProperties>
</file>